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0045700" cy="7777163"/>
  <p:notesSz cx="6858000" cy="9144000"/>
  <p:defaultTextStyle>
    <a:defPPr>
      <a:defRPr lang="ja-JP"/>
    </a:defPPr>
    <a:lvl1pPr marL="0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1pPr>
    <a:lvl2pPr marL="486049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2pPr>
    <a:lvl3pPr marL="972099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3pPr>
    <a:lvl4pPr marL="1458148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4pPr>
    <a:lvl5pPr marL="1944197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5pPr>
    <a:lvl6pPr marL="2430247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6pPr>
    <a:lvl7pPr marL="2916296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7pPr>
    <a:lvl8pPr marL="3402345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8pPr>
    <a:lvl9pPr marL="3888395" algn="l" defTabSz="972099" rtl="0" eaLnBrk="1" latinLnBrk="0" hangingPunct="1">
      <a:defRPr kumimoji="1" sz="1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02" y="-72"/>
      </p:cViewPr>
      <p:guideLst>
        <p:guide orient="horz" pos="2450"/>
        <p:guide pos="3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7A30F5-76D7-4BAB-ABD6-939036EE75A7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14438" y="685800"/>
            <a:ext cx="4429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4B141D-67FB-4233-B9CF-FB023A07D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126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1pPr>
    <a:lvl2pPr marL="486049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2pPr>
    <a:lvl3pPr marL="972099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3pPr>
    <a:lvl4pPr marL="1458148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4pPr>
    <a:lvl5pPr marL="1944197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5pPr>
    <a:lvl6pPr marL="2430247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6pPr>
    <a:lvl7pPr marL="2916296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7pPr>
    <a:lvl8pPr marL="3402345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8pPr>
    <a:lvl9pPr marL="3888395" algn="l" defTabSz="972099" rtl="0" eaLnBrk="1" latinLnBrk="0" hangingPunct="1">
      <a:defRPr kumimoji="1"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53428" y="2415963"/>
            <a:ext cx="8538845" cy="166704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06855" y="4407059"/>
            <a:ext cx="7031990" cy="198749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60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20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58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44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02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16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02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88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42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587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890060" y="311449"/>
            <a:ext cx="2448640" cy="6635792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44143" y="311449"/>
            <a:ext cx="7178490" cy="663579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855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305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93541" y="4997549"/>
            <a:ext cx="8538845" cy="1544631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93541" y="3296294"/>
            <a:ext cx="8538845" cy="1701254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604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7209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5814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4419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302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1629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023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8839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7234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44142" y="1814673"/>
            <a:ext cx="4813565" cy="5132568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525135" y="1814673"/>
            <a:ext cx="4813565" cy="5132568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965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02285" y="311447"/>
            <a:ext cx="9041130" cy="1296194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02285" y="1740861"/>
            <a:ext cx="4438595" cy="725508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6049" indent="0">
              <a:buNone/>
              <a:defRPr sz="2100" b="1"/>
            </a:lvl2pPr>
            <a:lvl3pPr marL="972099" indent="0">
              <a:buNone/>
              <a:defRPr sz="1900" b="1"/>
            </a:lvl3pPr>
            <a:lvl4pPr marL="1458148" indent="0">
              <a:buNone/>
              <a:defRPr sz="1700" b="1"/>
            </a:lvl4pPr>
            <a:lvl5pPr marL="1944197" indent="0">
              <a:buNone/>
              <a:defRPr sz="1700" b="1"/>
            </a:lvl5pPr>
            <a:lvl6pPr marL="2430247" indent="0">
              <a:buNone/>
              <a:defRPr sz="1700" b="1"/>
            </a:lvl6pPr>
            <a:lvl7pPr marL="2916296" indent="0">
              <a:buNone/>
              <a:defRPr sz="1700" b="1"/>
            </a:lvl7pPr>
            <a:lvl8pPr marL="3402345" indent="0">
              <a:buNone/>
              <a:defRPr sz="1700" b="1"/>
            </a:lvl8pPr>
            <a:lvl9pPr marL="3888395" indent="0">
              <a:buNone/>
              <a:defRPr sz="17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2285" y="2466369"/>
            <a:ext cx="4438595" cy="4480871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103077" y="1740861"/>
            <a:ext cx="4440339" cy="725508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86049" indent="0">
              <a:buNone/>
              <a:defRPr sz="2100" b="1"/>
            </a:lvl2pPr>
            <a:lvl3pPr marL="972099" indent="0">
              <a:buNone/>
              <a:defRPr sz="1900" b="1"/>
            </a:lvl3pPr>
            <a:lvl4pPr marL="1458148" indent="0">
              <a:buNone/>
              <a:defRPr sz="1700" b="1"/>
            </a:lvl4pPr>
            <a:lvl5pPr marL="1944197" indent="0">
              <a:buNone/>
              <a:defRPr sz="1700" b="1"/>
            </a:lvl5pPr>
            <a:lvl6pPr marL="2430247" indent="0">
              <a:buNone/>
              <a:defRPr sz="1700" b="1"/>
            </a:lvl6pPr>
            <a:lvl7pPr marL="2916296" indent="0">
              <a:buNone/>
              <a:defRPr sz="1700" b="1"/>
            </a:lvl7pPr>
            <a:lvl8pPr marL="3402345" indent="0">
              <a:buNone/>
              <a:defRPr sz="1700" b="1"/>
            </a:lvl8pPr>
            <a:lvl9pPr marL="3888395" indent="0">
              <a:buNone/>
              <a:defRPr sz="17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103077" y="2466369"/>
            <a:ext cx="4440339" cy="4480871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2492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78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783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02285" y="309646"/>
            <a:ext cx="3304966" cy="131779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927590" y="309648"/>
            <a:ext cx="5615825" cy="6637593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6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02285" y="1627445"/>
            <a:ext cx="3304966" cy="5319796"/>
          </a:xfrm>
        </p:spPr>
        <p:txBody>
          <a:bodyPr/>
          <a:lstStyle>
            <a:lvl1pPr marL="0" indent="0">
              <a:buNone/>
              <a:defRPr sz="1500"/>
            </a:lvl1pPr>
            <a:lvl2pPr marL="486049" indent="0">
              <a:buNone/>
              <a:defRPr sz="1300"/>
            </a:lvl2pPr>
            <a:lvl3pPr marL="972099" indent="0">
              <a:buNone/>
              <a:defRPr sz="1100"/>
            </a:lvl3pPr>
            <a:lvl4pPr marL="1458148" indent="0">
              <a:buNone/>
              <a:defRPr sz="1000"/>
            </a:lvl4pPr>
            <a:lvl5pPr marL="1944197" indent="0">
              <a:buNone/>
              <a:defRPr sz="1000"/>
            </a:lvl5pPr>
            <a:lvl6pPr marL="2430247" indent="0">
              <a:buNone/>
              <a:defRPr sz="1000"/>
            </a:lvl6pPr>
            <a:lvl7pPr marL="2916296" indent="0">
              <a:buNone/>
              <a:defRPr sz="1000"/>
            </a:lvl7pPr>
            <a:lvl8pPr marL="3402345" indent="0">
              <a:buNone/>
              <a:defRPr sz="1000"/>
            </a:lvl8pPr>
            <a:lvl9pPr marL="3888395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6554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69027" y="5444014"/>
            <a:ext cx="6027420" cy="64269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69027" y="694904"/>
            <a:ext cx="6027420" cy="4666298"/>
          </a:xfrm>
        </p:spPr>
        <p:txBody>
          <a:bodyPr/>
          <a:lstStyle>
            <a:lvl1pPr marL="0" indent="0">
              <a:buNone/>
              <a:defRPr sz="3400"/>
            </a:lvl1pPr>
            <a:lvl2pPr marL="486049" indent="0">
              <a:buNone/>
              <a:defRPr sz="3000"/>
            </a:lvl2pPr>
            <a:lvl3pPr marL="972099" indent="0">
              <a:buNone/>
              <a:defRPr sz="2600"/>
            </a:lvl3pPr>
            <a:lvl4pPr marL="1458148" indent="0">
              <a:buNone/>
              <a:defRPr sz="2100"/>
            </a:lvl4pPr>
            <a:lvl5pPr marL="1944197" indent="0">
              <a:buNone/>
              <a:defRPr sz="2100"/>
            </a:lvl5pPr>
            <a:lvl6pPr marL="2430247" indent="0">
              <a:buNone/>
              <a:defRPr sz="2100"/>
            </a:lvl6pPr>
            <a:lvl7pPr marL="2916296" indent="0">
              <a:buNone/>
              <a:defRPr sz="2100"/>
            </a:lvl7pPr>
            <a:lvl8pPr marL="3402345" indent="0">
              <a:buNone/>
              <a:defRPr sz="2100"/>
            </a:lvl8pPr>
            <a:lvl9pPr marL="3888395" indent="0">
              <a:buNone/>
              <a:defRPr sz="21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69027" y="6086711"/>
            <a:ext cx="6027420" cy="912736"/>
          </a:xfrm>
        </p:spPr>
        <p:txBody>
          <a:bodyPr/>
          <a:lstStyle>
            <a:lvl1pPr marL="0" indent="0">
              <a:buNone/>
              <a:defRPr sz="1500"/>
            </a:lvl1pPr>
            <a:lvl2pPr marL="486049" indent="0">
              <a:buNone/>
              <a:defRPr sz="1300"/>
            </a:lvl2pPr>
            <a:lvl3pPr marL="972099" indent="0">
              <a:buNone/>
              <a:defRPr sz="1100"/>
            </a:lvl3pPr>
            <a:lvl4pPr marL="1458148" indent="0">
              <a:buNone/>
              <a:defRPr sz="1000"/>
            </a:lvl4pPr>
            <a:lvl5pPr marL="1944197" indent="0">
              <a:buNone/>
              <a:defRPr sz="1000"/>
            </a:lvl5pPr>
            <a:lvl6pPr marL="2430247" indent="0">
              <a:buNone/>
              <a:defRPr sz="1000"/>
            </a:lvl6pPr>
            <a:lvl7pPr marL="2916296" indent="0">
              <a:buNone/>
              <a:defRPr sz="1000"/>
            </a:lvl7pPr>
            <a:lvl8pPr marL="3402345" indent="0">
              <a:buNone/>
              <a:defRPr sz="1000"/>
            </a:lvl8pPr>
            <a:lvl9pPr marL="3888395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869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02285" y="311447"/>
            <a:ext cx="9041130" cy="1296194"/>
          </a:xfrm>
          <a:prstGeom prst="rect">
            <a:avLst/>
          </a:prstGeom>
        </p:spPr>
        <p:txBody>
          <a:bodyPr vert="horz" lIns="97210" tIns="48605" rIns="97210" bIns="48605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02285" y="1814673"/>
            <a:ext cx="9041130" cy="5132568"/>
          </a:xfrm>
          <a:prstGeom prst="rect">
            <a:avLst/>
          </a:prstGeom>
        </p:spPr>
        <p:txBody>
          <a:bodyPr vert="horz" lIns="97210" tIns="48605" rIns="97210" bIns="48605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02285" y="7208280"/>
            <a:ext cx="2343997" cy="414062"/>
          </a:xfrm>
          <a:prstGeom prst="rect">
            <a:avLst/>
          </a:prstGeom>
        </p:spPr>
        <p:txBody>
          <a:bodyPr vert="horz" lIns="97210" tIns="48605" rIns="97210" bIns="48605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11284-5B97-4EDA-B344-D9744FA2C698}" type="datetimeFigureOut">
              <a:rPr kumimoji="1" lang="ja-JP" altLang="en-US" smtClean="0"/>
              <a:t>2015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432281" y="7208280"/>
            <a:ext cx="3181138" cy="414062"/>
          </a:xfrm>
          <a:prstGeom prst="rect">
            <a:avLst/>
          </a:prstGeom>
        </p:spPr>
        <p:txBody>
          <a:bodyPr vert="horz" lIns="97210" tIns="48605" rIns="97210" bIns="48605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199418" y="7208280"/>
            <a:ext cx="2343997" cy="414062"/>
          </a:xfrm>
          <a:prstGeom prst="rect">
            <a:avLst/>
          </a:prstGeom>
        </p:spPr>
        <p:txBody>
          <a:bodyPr vert="horz" lIns="97210" tIns="48605" rIns="97210" bIns="48605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20543-A4DC-466A-9F26-0075BC8ED9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044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72099" rtl="0" eaLnBrk="1" latinLnBrk="0" hangingPunct="1">
        <a:spcBef>
          <a:spcPct val="0"/>
        </a:spcBef>
        <a:buNone/>
        <a:defRPr kumimoji="1"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4537" indent="-364537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89830" indent="-303781" algn="l" defTabSz="972099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15123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01173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87222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73271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59321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45370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31419" indent="-243025" algn="l" defTabSz="97209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6049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72099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58148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44197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30247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16296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02345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8395" algn="l" defTabSz="972099" rtl="0" eaLnBrk="1" latinLnBrk="0" hangingPunct="1"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771423" y="761067"/>
            <a:ext cx="1846681" cy="298202"/>
          </a:xfrm>
          <a:prstGeom prst="rect">
            <a:avLst/>
          </a:prstGeom>
          <a:noFill/>
        </p:spPr>
        <p:txBody>
          <a:bodyPr wrap="none" lIns="97197" tIns="48599" rIns="97197" bIns="48599" rtlCol="0">
            <a:spAutoFit/>
          </a:bodyPr>
          <a:lstStyle/>
          <a:p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endParaRPr lang="ja-JP" alt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7984620"/>
              </p:ext>
            </p:extLst>
          </p:nvPr>
        </p:nvGraphicFramePr>
        <p:xfrm>
          <a:off x="774379" y="1157372"/>
          <a:ext cx="8496937" cy="4253200"/>
        </p:xfrm>
        <a:graphic>
          <a:graphicData uri="http://schemas.openxmlformats.org/drawingml/2006/table">
            <a:tbl>
              <a:tblPr/>
              <a:tblGrid>
                <a:gridCol w="303542"/>
                <a:gridCol w="732074"/>
                <a:gridCol w="908599"/>
                <a:gridCol w="218526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  <a:gridCol w="287918"/>
              </a:tblGrid>
              <a:tr h="2073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effectLst/>
                          <a:latin typeface="Times New Roman"/>
                        </a:rPr>
                        <a:t>Strain No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effectLst/>
                          <a:latin typeface="Times New Roman"/>
                        </a:rPr>
                        <a:t>Bacterial strai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effectLst/>
                          <a:latin typeface="Times New Roman"/>
                        </a:rPr>
                        <a:t>specime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ABPC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PIPC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TAZ/ PIPC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PD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EZ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MZ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FMO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AZ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T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PZ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FP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AZ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P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LVF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AM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G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MI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TOB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PF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ZOP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MEP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AMPC/CV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aginal flui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atheter 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atheter 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Pus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aginal flui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.coli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（</a:t>
                      </a:r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ESBL</a:t>
                      </a:r>
                      <a:r>
                        <a:rPr lang="en-US" sz="700" b="0" i="1" u="none" strike="noStrike">
                          <a:effectLst/>
                          <a:latin typeface="ＭＳ Ｐゴシック"/>
                        </a:rPr>
                        <a:t>）</a:t>
                      </a:r>
                      <a:endParaRPr lang="en-US" sz="700" b="0" i="1" u="none" strike="noStrike">
                        <a:effectLst/>
                        <a:latin typeface="Times New Roman"/>
                      </a:endParaRP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Venous 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putum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Wounde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Blood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Catheter 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putum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 smtClean="0">
                          <a:effectLst/>
                          <a:latin typeface="Times New Roman"/>
                        </a:rPr>
                        <a:t>Pleural </a:t>
                      </a:r>
                      <a:r>
                        <a:rPr lang="en-US" sz="700" b="0" i="0" u="none" strike="noStrike" dirty="0">
                          <a:effectLst/>
                          <a:latin typeface="Times New Roman"/>
                        </a:rPr>
                        <a:t>effusion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Sputum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Pharyngeal mucus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Urine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>
                          <a:effectLst/>
                          <a:latin typeface="Times New Roman"/>
                        </a:rPr>
                        <a:t>2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effectLst/>
                          <a:latin typeface="Times New Roman"/>
                        </a:rPr>
                        <a:t>P.aeruginosa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Pus</a:t>
                      </a:r>
                    </a:p>
                  </a:txBody>
                  <a:tcPr marL="129022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effectLst/>
                          <a:latin typeface="Times New Roman"/>
                        </a:rPr>
                        <a:t>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effectLst/>
                          <a:latin typeface="Times New Roman"/>
                        </a:rPr>
                        <a:t>N.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0640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5</TotalTime>
  <Words>783</Words>
  <Application>Microsoft Office PowerPoint</Application>
  <PresentationFormat>ユーザー設定</PresentationFormat>
  <Paragraphs>75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洋志</dc:creator>
  <cp:lastModifiedBy>伊藤</cp:lastModifiedBy>
  <cp:revision>16</cp:revision>
  <dcterms:created xsi:type="dcterms:W3CDTF">2014-05-05T11:10:06Z</dcterms:created>
  <dcterms:modified xsi:type="dcterms:W3CDTF">2015-03-11T08:19:06Z</dcterms:modified>
</cp:coreProperties>
</file>